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0F25061-6C29-4F02-94FA-BA7C574E9E1C}" v="1" dt="2022-08-30T17:12:10.3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5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098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gar Sofiyeva" userId="d39a9056-b92e-4cc7-a525-2313fa5cd2cb" providerId="ADAL" clId="{A8FAF545-0F1A-471A-82F9-68DD9375FA5F}"/>
    <pc:docChg chg="undo custSel modSld">
      <pc:chgData name="Nigar Sofiyeva" userId="d39a9056-b92e-4cc7-a525-2313fa5cd2cb" providerId="ADAL" clId="{A8FAF545-0F1A-471A-82F9-68DD9375FA5F}" dt="2022-03-23T23:35:22.500" v="23" actId="1076"/>
      <pc:docMkLst>
        <pc:docMk/>
      </pc:docMkLst>
      <pc:sldChg chg="addSp delSp modSp mod">
        <pc:chgData name="Nigar Sofiyeva" userId="d39a9056-b92e-4cc7-a525-2313fa5cd2cb" providerId="ADAL" clId="{A8FAF545-0F1A-471A-82F9-68DD9375FA5F}" dt="2022-03-23T23:26:18.473" v="9" actId="1076"/>
        <pc:sldMkLst>
          <pc:docMk/>
          <pc:sldMk cId="3455137915" sldId="257"/>
        </pc:sldMkLst>
        <pc:picChg chg="add del">
          <ac:chgData name="Nigar Sofiyeva" userId="d39a9056-b92e-4cc7-a525-2313fa5cd2cb" providerId="ADAL" clId="{A8FAF545-0F1A-471A-82F9-68DD9375FA5F}" dt="2022-03-23T23:26:07.450" v="2" actId="478"/>
          <ac:picMkLst>
            <pc:docMk/>
            <pc:sldMk cId="3455137915" sldId="257"/>
            <ac:picMk id="3" creationId="{C337BDD6-0177-4F35-85B5-3DD7BD3760B4}"/>
          </ac:picMkLst>
        </pc:picChg>
        <pc:picChg chg="add mod">
          <ac:chgData name="Nigar Sofiyeva" userId="d39a9056-b92e-4cc7-a525-2313fa5cd2cb" providerId="ADAL" clId="{A8FAF545-0F1A-471A-82F9-68DD9375FA5F}" dt="2022-03-23T23:26:18.473" v="9" actId="1076"/>
          <ac:picMkLst>
            <pc:docMk/>
            <pc:sldMk cId="3455137915" sldId="257"/>
            <ac:picMk id="4" creationId="{952DA984-B4AC-438E-B823-998EABDF0AFE}"/>
          </ac:picMkLst>
        </pc:picChg>
      </pc:sldChg>
      <pc:sldChg chg="addSp delSp modSp mod">
        <pc:chgData name="Nigar Sofiyeva" userId="d39a9056-b92e-4cc7-a525-2313fa5cd2cb" providerId="ADAL" clId="{A8FAF545-0F1A-471A-82F9-68DD9375FA5F}" dt="2022-03-23T23:30:37.795" v="17" actId="1076"/>
        <pc:sldMkLst>
          <pc:docMk/>
          <pc:sldMk cId="3607890359" sldId="258"/>
        </pc:sldMkLst>
        <pc:picChg chg="del">
          <ac:chgData name="Nigar Sofiyeva" userId="d39a9056-b92e-4cc7-a525-2313fa5cd2cb" providerId="ADAL" clId="{A8FAF545-0F1A-471A-82F9-68DD9375FA5F}" dt="2022-03-23T23:30:29.363" v="10" actId="478"/>
          <ac:picMkLst>
            <pc:docMk/>
            <pc:sldMk cId="3607890359" sldId="258"/>
            <ac:picMk id="3" creationId="{9BEE5500-4267-44C1-B342-0F7DD86B31D3}"/>
          </ac:picMkLst>
        </pc:picChg>
        <pc:picChg chg="add mod">
          <ac:chgData name="Nigar Sofiyeva" userId="d39a9056-b92e-4cc7-a525-2313fa5cd2cb" providerId="ADAL" clId="{A8FAF545-0F1A-471A-82F9-68DD9375FA5F}" dt="2022-03-23T23:30:37.795" v="17" actId="1076"/>
          <ac:picMkLst>
            <pc:docMk/>
            <pc:sldMk cId="3607890359" sldId="258"/>
            <ac:picMk id="4" creationId="{C87E0E74-926D-4C84-A7A4-A984AE2907ED}"/>
          </ac:picMkLst>
        </pc:picChg>
      </pc:sldChg>
      <pc:sldChg chg="addSp delSp modSp mod">
        <pc:chgData name="Nigar Sofiyeva" userId="d39a9056-b92e-4cc7-a525-2313fa5cd2cb" providerId="ADAL" clId="{A8FAF545-0F1A-471A-82F9-68DD9375FA5F}" dt="2022-03-23T23:35:22.500" v="23" actId="1076"/>
        <pc:sldMkLst>
          <pc:docMk/>
          <pc:sldMk cId="1549782722" sldId="259"/>
        </pc:sldMkLst>
        <pc:picChg chg="del">
          <ac:chgData name="Nigar Sofiyeva" userId="d39a9056-b92e-4cc7-a525-2313fa5cd2cb" providerId="ADAL" clId="{A8FAF545-0F1A-471A-82F9-68DD9375FA5F}" dt="2022-03-23T23:35:14.895" v="18" actId="478"/>
          <ac:picMkLst>
            <pc:docMk/>
            <pc:sldMk cId="1549782722" sldId="259"/>
            <ac:picMk id="3" creationId="{30FF8781-C20D-48FB-81F9-5B1DA6F358C7}"/>
          </ac:picMkLst>
        </pc:picChg>
        <pc:picChg chg="add mod">
          <ac:chgData name="Nigar Sofiyeva" userId="d39a9056-b92e-4cc7-a525-2313fa5cd2cb" providerId="ADAL" clId="{A8FAF545-0F1A-471A-82F9-68DD9375FA5F}" dt="2022-03-23T23:35:22.500" v="23" actId="1076"/>
          <ac:picMkLst>
            <pc:docMk/>
            <pc:sldMk cId="1549782722" sldId="259"/>
            <ac:picMk id="4" creationId="{5CCFC48C-22E5-4B34-969E-F15CD94F38C5}"/>
          </ac:picMkLst>
        </pc:picChg>
      </pc:sldChg>
    </pc:docChg>
  </pc:docChgLst>
  <pc:docChgLst>
    <pc:chgData name="Stian Knappskog" userId="fd9e34d2-1fd7-4b4b-9e0f-0cfc302beb73" providerId="ADAL" clId="{ABA4C4AC-4969-4D04-B252-B68E2A7D12AA}"/>
    <pc:docChg chg="modSld">
      <pc:chgData name="Stian Knappskog" userId="fd9e34d2-1fd7-4b4b-9e0f-0cfc302beb73" providerId="ADAL" clId="{ABA4C4AC-4969-4D04-B252-B68E2A7D12AA}" dt="2022-03-04T16:32:13.271" v="6" actId="20577"/>
      <pc:docMkLst>
        <pc:docMk/>
      </pc:docMkLst>
      <pc:sldChg chg="addSp modSp mod">
        <pc:chgData name="Stian Knappskog" userId="fd9e34d2-1fd7-4b4b-9e0f-0cfc302beb73" providerId="ADAL" clId="{ABA4C4AC-4969-4D04-B252-B68E2A7D12AA}" dt="2022-03-04T16:32:13.271" v="6" actId="20577"/>
        <pc:sldMkLst>
          <pc:docMk/>
          <pc:sldMk cId="867370080" sldId="260"/>
        </pc:sldMkLst>
        <pc:spChg chg="add mod">
          <ac:chgData name="Stian Knappskog" userId="fd9e34d2-1fd7-4b4b-9e0f-0cfc302beb73" providerId="ADAL" clId="{ABA4C4AC-4969-4D04-B252-B68E2A7D12AA}" dt="2022-03-04T16:32:04.373" v="2" actId="1076"/>
          <ac:spMkLst>
            <pc:docMk/>
            <pc:sldMk cId="867370080" sldId="260"/>
            <ac:spMk id="2" creationId="{74A3B1A0-5F94-48FE-A585-CADFE0B5C56E}"/>
          </ac:spMkLst>
        </pc:spChg>
        <pc:spChg chg="add mod">
          <ac:chgData name="Stian Knappskog" userId="fd9e34d2-1fd7-4b4b-9e0f-0cfc302beb73" providerId="ADAL" clId="{ABA4C4AC-4969-4D04-B252-B68E2A7D12AA}" dt="2022-03-04T16:32:13.271" v="6" actId="20577"/>
          <ac:spMkLst>
            <pc:docMk/>
            <pc:sldMk cId="867370080" sldId="260"/>
            <ac:spMk id="7" creationId="{F8F73FF7-4FE8-4BB8-A795-5BF9A2090CFD}"/>
          </ac:spMkLst>
        </pc:spChg>
      </pc:sldChg>
    </pc:docChg>
  </pc:docChgLst>
  <pc:docChgLst>
    <pc:chgData name="Nigar Sofiyeva" userId="d39a9056-b92e-4cc7-a525-2313fa5cd2cb" providerId="ADAL" clId="{A07566C4-ED07-41E0-B08A-1047287E0E33}"/>
    <pc:docChg chg="custSel modSld">
      <pc:chgData name="Nigar Sofiyeva" userId="d39a9056-b92e-4cc7-a525-2313fa5cd2cb" providerId="ADAL" clId="{A07566C4-ED07-41E0-B08A-1047287E0E33}" dt="2022-03-30T13:46:55.916" v="23" actId="1076"/>
      <pc:docMkLst>
        <pc:docMk/>
      </pc:docMkLst>
      <pc:sldChg chg="addSp delSp modSp mod">
        <pc:chgData name="Nigar Sofiyeva" userId="d39a9056-b92e-4cc7-a525-2313fa5cd2cb" providerId="ADAL" clId="{A07566C4-ED07-41E0-B08A-1047287E0E33}" dt="2022-03-30T13:46:55.916" v="23" actId="1076"/>
        <pc:sldMkLst>
          <pc:docMk/>
          <pc:sldMk cId="867370080" sldId="260"/>
        </pc:sldMkLst>
        <pc:spChg chg="del">
          <ac:chgData name="Nigar Sofiyeva" userId="d39a9056-b92e-4cc7-a525-2313fa5cd2cb" providerId="ADAL" clId="{A07566C4-ED07-41E0-B08A-1047287E0E33}" dt="2022-03-30T13:34:02.739" v="2" actId="478"/>
          <ac:spMkLst>
            <pc:docMk/>
            <pc:sldMk cId="867370080" sldId="260"/>
            <ac:spMk id="2" creationId="{74A3B1A0-5F94-48FE-A585-CADFE0B5C56E}"/>
          </ac:spMkLst>
        </pc:spChg>
        <pc:spChg chg="del">
          <ac:chgData name="Nigar Sofiyeva" userId="d39a9056-b92e-4cc7-a525-2313fa5cd2cb" providerId="ADAL" clId="{A07566C4-ED07-41E0-B08A-1047287E0E33}" dt="2022-03-30T13:34:02.739" v="2" actId="478"/>
          <ac:spMkLst>
            <pc:docMk/>
            <pc:sldMk cId="867370080" sldId="260"/>
            <ac:spMk id="7" creationId="{F8F73FF7-4FE8-4BB8-A795-5BF9A2090CFD}"/>
          </ac:spMkLst>
        </pc:spChg>
        <pc:picChg chg="add mod">
          <ac:chgData name="Nigar Sofiyeva" userId="d39a9056-b92e-4cc7-a525-2313fa5cd2cb" providerId="ADAL" clId="{A07566C4-ED07-41E0-B08A-1047287E0E33}" dt="2022-03-30T13:46:55.916" v="23" actId="1076"/>
          <ac:picMkLst>
            <pc:docMk/>
            <pc:sldMk cId="867370080" sldId="260"/>
            <ac:picMk id="3" creationId="{C8DC47F1-4E0F-40F0-B55A-9A6E76D942CC}"/>
          </ac:picMkLst>
        </pc:picChg>
        <pc:picChg chg="del">
          <ac:chgData name="Nigar Sofiyeva" userId="d39a9056-b92e-4cc7-a525-2313fa5cd2cb" providerId="ADAL" clId="{A07566C4-ED07-41E0-B08A-1047287E0E33}" dt="2022-03-30T13:33:58.901" v="0" actId="478"/>
          <ac:picMkLst>
            <pc:docMk/>
            <pc:sldMk cId="867370080" sldId="260"/>
            <ac:picMk id="5" creationId="{AE1C8DE7-F1A0-4D35-AD96-37AFE9377B87}"/>
          </ac:picMkLst>
        </pc:picChg>
        <pc:picChg chg="del">
          <ac:chgData name="Nigar Sofiyeva" userId="d39a9056-b92e-4cc7-a525-2313fa5cd2cb" providerId="ADAL" clId="{A07566C4-ED07-41E0-B08A-1047287E0E33}" dt="2022-03-30T13:33:59.354" v="1" actId="478"/>
          <ac:picMkLst>
            <pc:docMk/>
            <pc:sldMk cId="867370080" sldId="260"/>
            <ac:picMk id="6" creationId="{70034EE6-D1F7-4129-9F1B-D7E1332B52A6}"/>
          </ac:picMkLst>
        </pc:picChg>
        <pc:picChg chg="add del mod">
          <ac:chgData name="Nigar Sofiyeva" userId="d39a9056-b92e-4cc7-a525-2313fa5cd2cb" providerId="ADAL" clId="{A07566C4-ED07-41E0-B08A-1047287E0E33}" dt="2022-03-30T13:36:50.924" v="8" actId="478"/>
          <ac:picMkLst>
            <pc:docMk/>
            <pc:sldMk cId="867370080" sldId="260"/>
            <ac:picMk id="8" creationId="{89BD5B88-B393-4DFE-8C94-3FA73B292D56}"/>
          </ac:picMkLst>
        </pc:picChg>
        <pc:picChg chg="add del mod">
          <ac:chgData name="Nigar Sofiyeva" userId="d39a9056-b92e-4cc7-a525-2313fa5cd2cb" providerId="ADAL" clId="{A07566C4-ED07-41E0-B08A-1047287E0E33}" dt="2022-03-30T13:46:43.389" v="16" actId="478"/>
          <ac:picMkLst>
            <pc:docMk/>
            <pc:sldMk cId="867370080" sldId="260"/>
            <ac:picMk id="10" creationId="{FA5872E7-54B8-42D3-B138-082BB27BAA1B}"/>
          </ac:picMkLst>
        </pc:picChg>
      </pc:sldChg>
    </pc:docChg>
  </pc:docChgLst>
  <pc:docChgLst>
    <pc:chgData name="Nigar Sofiyeva" userId="d39a9056-b92e-4cc7-a525-2313fa5cd2cb" providerId="ADAL" clId="{FCF1FBAB-28B0-4ABD-BDC3-FCC9715218DA}"/>
    <pc:docChg chg="undo custSel modSld">
      <pc:chgData name="Nigar Sofiyeva" userId="d39a9056-b92e-4cc7-a525-2313fa5cd2cb" providerId="ADAL" clId="{FCF1FBAB-28B0-4ABD-BDC3-FCC9715218DA}" dt="2021-07-29T12:08:32.543" v="82" actId="962"/>
      <pc:docMkLst>
        <pc:docMk/>
      </pc:docMkLst>
      <pc:sldChg chg="addSp delSp modSp mod">
        <pc:chgData name="Nigar Sofiyeva" userId="d39a9056-b92e-4cc7-a525-2313fa5cd2cb" providerId="ADAL" clId="{FCF1FBAB-28B0-4ABD-BDC3-FCC9715218DA}" dt="2021-07-29T10:54:12.593" v="75" actId="1076"/>
        <pc:sldMkLst>
          <pc:docMk/>
          <pc:sldMk cId="3455137915" sldId="257"/>
        </pc:sldMkLst>
        <pc:spChg chg="del">
          <ac:chgData name="Nigar Sofiyeva" userId="d39a9056-b92e-4cc7-a525-2313fa5cd2cb" providerId="ADAL" clId="{FCF1FBAB-28B0-4ABD-BDC3-FCC9715218DA}" dt="2021-07-28T00:06:04.036" v="0" actId="478"/>
          <ac:spMkLst>
            <pc:docMk/>
            <pc:sldMk cId="3455137915" sldId="257"/>
            <ac:spMk id="10" creationId="{BDA7058B-59A2-4C6F-B7CE-EBF77E24298D}"/>
          </ac:spMkLst>
        </pc:spChg>
        <pc:spChg chg="del">
          <ac:chgData name="Nigar Sofiyeva" userId="d39a9056-b92e-4cc7-a525-2313fa5cd2cb" providerId="ADAL" clId="{FCF1FBAB-28B0-4ABD-BDC3-FCC9715218DA}" dt="2021-07-28T00:06:11.158" v="2" actId="478"/>
          <ac:spMkLst>
            <pc:docMk/>
            <pc:sldMk cId="3455137915" sldId="257"/>
            <ac:spMk id="11" creationId="{C1DB2622-F3AE-4033-B7CF-A159E4CC6AE6}"/>
          </ac:spMkLst>
        </pc:spChg>
        <pc:picChg chg="add del mod">
          <ac:chgData name="Nigar Sofiyeva" userId="d39a9056-b92e-4cc7-a525-2313fa5cd2cb" providerId="ADAL" clId="{FCF1FBAB-28B0-4ABD-BDC3-FCC9715218DA}" dt="2021-07-28T00:08:11.949" v="6" actId="478"/>
          <ac:picMkLst>
            <pc:docMk/>
            <pc:sldMk cId="3455137915" sldId="257"/>
            <ac:picMk id="3" creationId="{39A6DABD-F2DD-4180-97E4-1CE34DB56B0E}"/>
          </ac:picMkLst>
        </pc:picChg>
        <pc:picChg chg="add del mod">
          <ac:chgData name="Nigar Sofiyeva" userId="d39a9056-b92e-4cc7-a525-2313fa5cd2cb" providerId="ADAL" clId="{FCF1FBAB-28B0-4ABD-BDC3-FCC9715218DA}" dt="2021-07-29T10:54:00.333" v="69" actId="478"/>
          <ac:picMkLst>
            <pc:docMk/>
            <pc:sldMk cId="3455137915" sldId="257"/>
            <ac:picMk id="3" creationId="{A8DCAB3C-4302-44D9-B2C5-D5F7EF72B46D}"/>
          </ac:picMkLst>
        </pc:picChg>
        <pc:picChg chg="add mod">
          <ac:chgData name="Nigar Sofiyeva" userId="d39a9056-b92e-4cc7-a525-2313fa5cd2cb" providerId="ADAL" clId="{FCF1FBAB-28B0-4ABD-BDC3-FCC9715218DA}" dt="2021-07-29T10:54:12.593" v="75" actId="1076"/>
          <ac:picMkLst>
            <pc:docMk/>
            <pc:sldMk cId="3455137915" sldId="257"/>
            <ac:picMk id="4" creationId="{CB79A772-F00E-413F-B1AB-A86C15FB054C}"/>
          </ac:picMkLst>
        </pc:picChg>
        <pc:picChg chg="add del mod">
          <ac:chgData name="Nigar Sofiyeva" userId="d39a9056-b92e-4cc7-a525-2313fa5cd2cb" providerId="ADAL" clId="{FCF1FBAB-28B0-4ABD-BDC3-FCC9715218DA}" dt="2021-07-28T00:08:23.748" v="10" actId="478"/>
          <ac:picMkLst>
            <pc:docMk/>
            <pc:sldMk cId="3455137915" sldId="257"/>
            <ac:picMk id="5" creationId="{6469A575-72D3-453E-8984-768DFBC9EA85}"/>
          </ac:picMkLst>
        </pc:picChg>
        <pc:picChg chg="del">
          <ac:chgData name="Nigar Sofiyeva" userId="d39a9056-b92e-4cc7-a525-2313fa5cd2cb" providerId="ADAL" clId="{FCF1FBAB-28B0-4ABD-BDC3-FCC9715218DA}" dt="2021-07-28T00:06:08.064" v="1" actId="478"/>
          <ac:picMkLst>
            <pc:docMk/>
            <pc:sldMk cId="3455137915" sldId="257"/>
            <ac:picMk id="6" creationId="{EEE70A50-4B63-4456-9F75-39E2B8DEBD1B}"/>
          </ac:picMkLst>
        </pc:picChg>
        <pc:picChg chg="add del mod">
          <ac:chgData name="Nigar Sofiyeva" userId="d39a9056-b92e-4cc7-a525-2313fa5cd2cb" providerId="ADAL" clId="{FCF1FBAB-28B0-4ABD-BDC3-FCC9715218DA}" dt="2021-07-28T15:40:17.546" v="43" actId="478"/>
          <ac:picMkLst>
            <pc:docMk/>
            <pc:sldMk cId="3455137915" sldId="257"/>
            <ac:picMk id="9" creationId="{F47586E1-8770-4D75-84CD-3286B91E07FD}"/>
          </ac:picMkLst>
        </pc:picChg>
      </pc:sldChg>
      <pc:sldChg chg="addSp delSp modSp mod">
        <pc:chgData name="Nigar Sofiyeva" userId="d39a9056-b92e-4cc7-a525-2313fa5cd2cb" providerId="ADAL" clId="{FCF1FBAB-28B0-4ABD-BDC3-FCC9715218DA}" dt="2021-07-29T10:38:55.368" v="68" actId="1076"/>
        <pc:sldMkLst>
          <pc:docMk/>
          <pc:sldMk cId="3607890359" sldId="258"/>
        </pc:sldMkLst>
        <pc:spChg chg="del">
          <ac:chgData name="Nigar Sofiyeva" userId="d39a9056-b92e-4cc7-a525-2313fa5cd2cb" providerId="ADAL" clId="{FCF1FBAB-28B0-4ABD-BDC3-FCC9715218DA}" dt="2021-07-28T00:08:41.841" v="17" actId="478"/>
          <ac:spMkLst>
            <pc:docMk/>
            <pc:sldMk cId="3607890359" sldId="258"/>
            <ac:spMk id="10" creationId="{BDA7058B-59A2-4C6F-B7CE-EBF77E24298D}"/>
          </ac:spMkLst>
        </pc:spChg>
        <pc:spChg chg="del">
          <ac:chgData name="Nigar Sofiyeva" userId="d39a9056-b92e-4cc7-a525-2313fa5cd2cb" providerId="ADAL" clId="{FCF1FBAB-28B0-4ABD-BDC3-FCC9715218DA}" dt="2021-07-28T00:08:47.213" v="18" actId="478"/>
          <ac:spMkLst>
            <pc:docMk/>
            <pc:sldMk cId="3607890359" sldId="258"/>
            <ac:spMk id="11" creationId="{C1DB2622-F3AE-4033-B7CF-A159E4CC6AE6}"/>
          </ac:spMkLst>
        </pc:spChg>
        <pc:picChg chg="del">
          <ac:chgData name="Nigar Sofiyeva" userId="d39a9056-b92e-4cc7-a525-2313fa5cd2cb" providerId="ADAL" clId="{FCF1FBAB-28B0-4ABD-BDC3-FCC9715218DA}" dt="2021-07-28T00:08:49.211" v="19" actId="478"/>
          <ac:picMkLst>
            <pc:docMk/>
            <pc:sldMk cId="3607890359" sldId="258"/>
            <ac:picMk id="3" creationId="{7FE61AD4-9FF5-4E16-AD61-AC7ED4DBDB67}"/>
          </ac:picMkLst>
        </pc:picChg>
        <pc:picChg chg="add del mod">
          <ac:chgData name="Nigar Sofiyeva" userId="d39a9056-b92e-4cc7-a525-2313fa5cd2cb" providerId="ADAL" clId="{FCF1FBAB-28B0-4ABD-BDC3-FCC9715218DA}" dt="2021-07-29T10:38:47.939" v="62" actId="478"/>
          <ac:picMkLst>
            <pc:docMk/>
            <pc:sldMk cId="3607890359" sldId="258"/>
            <ac:picMk id="3" creationId="{B2C934D9-7C1E-4722-9FCD-2CC118D0CFAE}"/>
          </ac:picMkLst>
        </pc:picChg>
        <pc:picChg chg="add del mod">
          <ac:chgData name="Nigar Sofiyeva" userId="d39a9056-b92e-4cc7-a525-2313fa5cd2cb" providerId="ADAL" clId="{FCF1FBAB-28B0-4ABD-BDC3-FCC9715218DA}" dt="2021-07-28T16:07:15.252" v="50" actId="478"/>
          <ac:picMkLst>
            <pc:docMk/>
            <pc:sldMk cId="3607890359" sldId="258"/>
            <ac:picMk id="4" creationId="{5F75E2F1-5030-4D72-BBFC-6C90C1377214}"/>
          </ac:picMkLst>
        </pc:picChg>
        <pc:picChg chg="add mod">
          <ac:chgData name="Nigar Sofiyeva" userId="d39a9056-b92e-4cc7-a525-2313fa5cd2cb" providerId="ADAL" clId="{FCF1FBAB-28B0-4ABD-BDC3-FCC9715218DA}" dt="2021-07-29T10:38:55.368" v="68" actId="1076"/>
          <ac:picMkLst>
            <pc:docMk/>
            <pc:sldMk cId="3607890359" sldId="258"/>
            <ac:picMk id="4" creationId="{C40871DB-248E-4E52-8728-41BA4A885841}"/>
          </ac:picMkLst>
        </pc:picChg>
      </pc:sldChg>
      <pc:sldChg chg="addSp delSp modSp mod">
        <pc:chgData name="Nigar Sofiyeva" userId="d39a9056-b92e-4cc7-a525-2313fa5cd2cb" providerId="ADAL" clId="{FCF1FBAB-28B0-4ABD-BDC3-FCC9715218DA}" dt="2021-07-29T12:08:32.543" v="82" actId="962"/>
        <pc:sldMkLst>
          <pc:docMk/>
          <pc:sldMk cId="1549782722" sldId="259"/>
        </pc:sldMkLst>
        <pc:spChg chg="del">
          <ac:chgData name="Nigar Sofiyeva" userId="d39a9056-b92e-4cc7-a525-2313fa5cd2cb" providerId="ADAL" clId="{FCF1FBAB-28B0-4ABD-BDC3-FCC9715218DA}" dt="2021-07-28T00:28:32.991" v="32" actId="478"/>
          <ac:spMkLst>
            <pc:docMk/>
            <pc:sldMk cId="1549782722" sldId="259"/>
            <ac:spMk id="10" creationId="{BDA7058B-59A2-4C6F-B7CE-EBF77E24298D}"/>
          </ac:spMkLst>
        </pc:spChg>
        <pc:spChg chg="del">
          <ac:chgData name="Nigar Sofiyeva" userId="d39a9056-b92e-4cc7-a525-2313fa5cd2cb" providerId="ADAL" clId="{FCF1FBAB-28B0-4ABD-BDC3-FCC9715218DA}" dt="2021-07-28T00:28:40.340" v="36" actId="478"/>
          <ac:spMkLst>
            <pc:docMk/>
            <pc:sldMk cId="1549782722" sldId="259"/>
            <ac:spMk id="11" creationId="{C1DB2622-F3AE-4033-B7CF-A159E4CC6AE6}"/>
          </ac:spMkLst>
        </pc:spChg>
        <pc:picChg chg="add del mod">
          <ac:chgData name="Nigar Sofiyeva" userId="d39a9056-b92e-4cc7-a525-2313fa5cd2cb" providerId="ADAL" clId="{FCF1FBAB-28B0-4ABD-BDC3-FCC9715218DA}" dt="2021-07-28T00:30:24.677" v="39" actId="478"/>
          <ac:picMkLst>
            <pc:docMk/>
            <pc:sldMk cId="1549782722" sldId="259"/>
            <ac:picMk id="3" creationId="{C07E0E28-F397-43B0-9EAA-86264BD5A75D}"/>
          </ac:picMkLst>
        </pc:picChg>
        <pc:picChg chg="add del mod">
          <ac:chgData name="Nigar Sofiyeva" userId="d39a9056-b92e-4cc7-a525-2313fa5cd2cb" providerId="ADAL" clId="{FCF1FBAB-28B0-4ABD-BDC3-FCC9715218DA}" dt="2021-07-29T12:08:28.721" v="78" actId="478"/>
          <ac:picMkLst>
            <pc:docMk/>
            <pc:sldMk cId="1549782722" sldId="259"/>
            <ac:picMk id="3" creationId="{FC551CB5-6508-4DE2-99A2-7D4400FC093A}"/>
          </ac:picMkLst>
        </pc:picChg>
        <pc:picChg chg="add mod">
          <ac:chgData name="Nigar Sofiyeva" userId="d39a9056-b92e-4cc7-a525-2313fa5cd2cb" providerId="ADAL" clId="{FCF1FBAB-28B0-4ABD-BDC3-FCC9715218DA}" dt="2021-07-29T12:08:32.543" v="82" actId="962"/>
          <ac:picMkLst>
            <pc:docMk/>
            <pc:sldMk cId="1549782722" sldId="259"/>
            <ac:picMk id="4" creationId="{65E31E23-1276-40C1-97E7-CC1421B2C17C}"/>
          </ac:picMkLst>
        </pc:picChg>
        <pc:picChg chg="del">
          <ac:chgData name="Nigar Sofiyeva" userId="d39a9056-b92e-4cc7-a525-2313fa5cd2cb" providerId="ADAL" clId="{FCF1FBAB-28B0-4ABD-BDC3-FCC9715218DA}" dt="2021-07-28T00:28:30.340" v="31" actId="478"/>
          <ac:picMkLst>
            <pc:docMk/>
            <pc:sldMk cId="1549782722" sldId="259"/>
            <ac:picMk id="4" creationId="{6C84D584-4900-4624-B0A7-BDBF37C3D756}"/>
          </ac:picMkLst>
        </pc:picChg>
        <pc:picChg chg="add del mod">
          <ac:chgData name="Nigar Sofiyeva" userId="d39a9056-b92e-4cc7-a525-2313fa5cd2cb" providerId="ADAL" clId="{FCF1FBAB-28B0-4ABD-BDC3-FCC9715218DA}" dt="2021-07-28T16:22:57.662" v="58" actId="478"/>
          <ac:picMkLst>
            <pc:docMk/>
            <pc:sldMk cId="1549782722" sldId="259"/>
            <ac:picMk id="6" creationId="{4ECAC6CE-DAEF-4715-B444-A6775C78B544}"/>
          </ac:picMkLst>
        </pc:picChg>
      </pc:sldChg>
    </pc:docChg>
  </pc:docChgLst>
  <pc:docChgLst>
    <pc:chgData name="Nigar Sofiyeva" userId="d39a9056-b92e-4cc7-a525-2313fa5cd2cb" providerId="ADAL" clId="{B0F25061-6C29-4F02-94FA-BA7C574E9E1C}"/>
    <pc:docChg chg="addSld delSld modSld">
      <pc:chgData name="Nigar Sofiyeva" userId="d39a9056-b92e-4cc7-a525-2313fa5cd2cb" providerId="ADAL" clId="{B0F25061-6C29-4F02-94FA-BA7C574E9E1C}" dt="2022-08-30T17:12:36.380" v="25" actId="20577"/>
      <pc:docMkLst>
        <pc:docMk/>
      </pc:docMkLst>
      <pc:sldChg chg="modSp mod">
        <pc:chgData name="Nigar Sofiyeva" userId="d39a9056-b92e-4cc7-a525-2313fa5cd2cb" providerId="ADAL" clId="{B0F25061-6C29-4F02-94FA-BA7C574E9E1C}" dt="2022-08-30T17:12:23.354" v="19" actId="20577"/>
        <pc:sldMkLst>
          <pc:docMk/>
          <pc:sldMk cId="3455137915" sldId="257"/>
        </pc:sldMkLst>
        <pc:spChg chg="mod">
          <ac:chgData name="Nigar Sofiyeva" userId="d39a9056-b92e-4cc7-a525-2313fa5cd2cb" providerId="ADAL" clId="{B0F25061-6C29-4F02-94FA-BA7C574E9E1C}" dt="2022-08-30T17:12:23.354" v="19" actId="20577"/>
          <ac:spMkLst>
            <pc:docMk/>
            <pc:sldMk cId="3455137915" sldId="257"/>
            <ac:spMk id="8" creationId="{CF2FFABC-C889-43CA-9B7A-02ECEF9C6226}"/>
          </ac:spMkLst>
        </pc:spChg>
      </pc:sldChg>
      <pc:sldChg chg="modSp mod">
        <pc:chgData name="Nigar Sofiyeva" userId="d39a9056-b92e-4cc7-a525-2313fa5cd2cb" providerId="ADAL" clId="{B0F25061-6C29-4F02-94FA-BA7C574E9E1C}" dt="2022-08-30T17:12:27.839" v="21" actId="20577"/>
        <pc:sldMkLst>
          <pc:docMk/>
          <pc:sldMk cId="3607890359" sldId="258"/>
        </pc:sldMkLst>
        <pc:spChg chg="mod">
          <ac:chgData name="Nigar Sofiyeva" userId="d39a9056-b92e-4cc7-a525-2313fa5cd2cb" providerId="ADAL" clId="{B0F25061-6C29-4F02-94FA-BA7C574E9E1C}" dt="2022-08-30T17:12:27.839" v="21" actId="20577"/>
          <ac:spMkLst>
            <pc:docMk/>
            <pc:sldMk cId="3607890359" sldId="258"/>
            <ac:spMk id="8" creationId="{CF2FFABC-C889-43CA-9B7A-02ECEF9C6226}"/>
          </ac:spMkLst>
        </pc:spChg>
      </pc:sldChg>
      <pc:sldChg chg="modSp mod">
        <pc:chgData name="Nigar Sofiyeva" userId="d39a9056-b92e-4cc7-a525-2313fa5cd2cb" providerId="ADAL" clId="{B0F25061-6C29-4F02-94FA-BA7C574E9E1C}" dt="2022-08-30T17:12:31.457" v="23" actId="20577"/>
        <pc:sldMkLst>
          <pc:docMk/>
          <pc:sldMk cId="1549782722" sldId="259"/>
        </pc:sldMkLst>
        <pc:spChg chg="mod">
          <ac:chgData name="Nigar Sofiyeva" userId="d39a9056-b92e-4cc7-a525-2313fa5cd2cb" providerId="ADAL" clId="{B0F25061-6C29-4F02-94FA-BA7C574E9E1C}" dt="2022-08-30T17:12:31.457" v="23" actId="20577"/>
          <ac:spMkLst>
            <pc:docMk/>
            <pc:sldMk cId="1549782722" sldId="259"/>
            <ac:spMk id="8" creationId="{CF2FFABC-C889-43CA-9B7A-02ECEF9C6226}"/>
          </ac:spMkLst>
        </pc:spChg>
      </pc:sldChg>
      <pc:sldChg chg="modSp mod">
        <pc:chgData name="Nigar Sofiyeva" userId="d39a9056-b92e-4cc7-a525-2313fa5cd2cb" providerId="ADAL" clId="{B0F25061-6C29-4F02-94FA-BA7C574E9E1C}" dt="2022-08-30T17:12:36.380" v="25" actId="20577"/>
        <pc:sldMkLst>
          <pc:docMk/>
          <pc:sldMk cId="867370080" sldId="260"/>
        </pc:sldMkLst>
        <pc:spChg chg="mod">
          <ac:chgData name="Nigar Sofiyeva" userId="d39a9056-b92e-4cc7-a525-2313fa5cd2cb" providerId="ADAL" clId="{B0F25061-6C29-4F02-94FA-BA7C574E9E1C}" dt="2022-08-30T17:12:36.380" v="25" actId="20577"/>
          <ac:spMkLst>
            <pc:docMk/>
            <pc:sldMk cId="867370080" sldId="260"/>
            <ac:spMk id="4" creationId="{C377720F-58A7-469B-AFCF-65646E9D6A9B}"/>
          </ac:spMkLst>
        </pc:spChg>
      </pc:sldChg>
      <pc:sldChg chg="new del">
        <pc:chgData name="Nigar Sofiyeva" userId="d39a9056-b92e-4cc7-a525-2313fa5cd2cb" providerId="ADAL" clId="{B0F25061-6C29-4F02-94FA-BA7C574E9E1C}" dt="2022-08-30T17:12:13.530" v="3" actId="47"/>
        <pc:sldMkLst>
          <pc:docMk/>
          <pc:sldMk cId="3356127193" sldId="261"/>
        </pc:sldMkLst>
      </pc:sldChg>
      <pc:sldChg chg="new del">
        <pc:chgData name="Nigar Sofiyeva" userId="d39a9056-b92e-4cc7-a525-2313fa5cd2cb" providerId="ADAL" clId="{B0F25061-6C29-4F02-94FA-BA7C574E9E1C}" dt="2022-08-30T17:12:11.839" v="2" actId="47"/>
        <pc:sldMkLst>
          <pc:docMk/>
          <pc:sldMk cId="1146778608" sldId="262"/>
        </pc:sldMkLst>
      </pc:sldChg>
      <pc:sldChg chg="modSp mod">
        <pc:chgData name="Nigar Sofiyeva" userId="d39a9056-b92e-4cc7-a525-2313fa5cd2cb" providerId="ADAL" clId="{B0F25061-6C29-4F02-94FA-BA7C574E9E1C}" dt="2022-08-30T17:12:18.522" v="17" actId="20577"/>
        <pc:sldMkLst>
          <pc:docMk/>
          <pc:sldMk cId="4007222331" sldId="263"/>
        </pc:sldMkLst>
        <pc:spChg chg="mod">
          <ac:chgData name="Nigar Sofiyeva" userId="d39a9056-b92e-4cc7-a525-2313fa5cd2cb" providerId="ADAL" clId="{B0F25061-6C29-4F02-94FA-BA7C574E9E1C}" dt="2022-08-30T17:12:18.522" v="17" actId="20577"/>
          <ac:spMkLst>
            <pc:docMk/>
            <pc:sldMk cId="4007222331" sldId="263"/>
            <ac:spMk id="8" creationId="{CF2FFABC-C889-43CA-9B7A-02ECEF9C6226}"/>
          </ac:spMkLst>
        </pc:spChg>
      </pc:sldChg>
    </pc:docChg>
  </pc:docChgLst>
  <pc:docChgLst>
    <pc:chgData name="Stian Knappskog" userId="fd9e34d2-1fd7-4b4b-9e0f-0cfc302beb73" providerId="ADAL" clId="{F24C2087-A6AD-41A2-8CF4-4A5DE4A7A253}"/>
    <pc:docChg chg="custSel addSld modSld">
      <pc:chgData name="Stian Knappskog" userId="fd9e34d2-1fd7-4b4b-9e0f-0cfc302beb73" providerId="ADAL" clId="{F24C2087-A6AD-41A2-8CF4-4A5DE4A7A253}" dt="2021-07-21T11:46:06.917" v="23" actId="13926"/>
      <pc:docMkLst>
        <pc:docMk/>
      </pc:docMkLst>
      <pc:sldChg chg="modSp mod">
        <pc:chgData name="Stian Knappskog" userId="fd9e34d2-1fd7-4b4b-9e0f-0cfc302beb73" providerId="ADAL" clId="{F24C2087-A6AD-41A2-8CF4-4A5DE4A7A253}" dt="2021-07-21T11:45:59.652" v="21" actId="13926"/>
        <pc:sldMkLst>
          <pc:docMk/>
          <pc:sldMk cId="3455137915" sldId="257"/>
        </pc:sldMkLst>
        <pc:spChg chg="mod">
          <ac:chgData name="Stian Knappskog" userId="fd9e34d2-1fd7-4b4b-9e0f-0cfc302beb73" providerId="ADAL" clId="{F24C2087-A6AD-41A2-8CF4-4A5DE4A7A253}" dt="2021-07-21T11:45:59.652" v="21" actId="13926"/>
          <ac:spMkLst>
            <pc:docMk/>
            <pc:sldMk cId="3455137915" sldId="257"/>
            <ac:spMk id="11" creationId="{C1DB2622-F3AE-4033-B7CF-A159E4CC6AE6}"/>
          </ac:spMkLst>
        </pc:spChg>
      </pc:sldChg>
      <pc:sldChg chg="addSp delSp modSp add mod">
        <pc:chgData name="Stian Knappskog" userId="fd9e34d2-1fd7-4b4b-9e0f-0cfc302beb73" providerId="ADAL" clId="{F24C2087-A6AD-41A2-8CF4-4A5DE4A7A253}" dt="2021-07-21T11:46:03.187" v="22" actId="13926"/>
        <pc:sldMkLst>
          <pc:docMk/>
          <pc:sldMk cId="3607890359" sldId="258"/>
        </pc:sldMkLst>
        <pc:spChg chg="mod">
          <ac:chgData name="Stian Knappskog" userId="fd9e34d2-1fd7-4b4b-9e0f-0cfc302beb73" providerId="ADAL" clId="{F24C2087-A6AD-41A2-8CF4-4A5DE4A7A253}" dt="2021-07-20T14:59:05.430" v="3" actId="6549"/>
          <ac:spMkLst>
            <pc:docMk/>
            <pc:sldMk cId="3607890359" sldId="258"/>
            <ac:spMk id="8" creationId="{CF2FFABC-C889-43CA-9B7A-02ECEF9C6226}"/>
          </ac:spMkLst>
        </pc:spChg>
        <pc:spChg chg="mod">
          <ac:chgData name="Stian Knappskog" userId="fd9e34d2-1fd7-4b4b-9e0f-0cfc302beb73" providerId="ADAL" clId="{F24C2087-A6AD-41A2-8CF4-4A5DE4A7A253}" dt="2021-07-21T11:46:03.187" v="22" actId="13926"/>
          <ac:spMkLst>
            <pc:docMk/>
            <pc:sldMk cId="3607890359" sldId="258"/>
            <ac:spMk id="11" creationId="{C1DB2622-F3AE-4033-B7CF-A159E4CC6AE6}"/>
          </ac:spMkLst>
        </pc:spChg>
        <pc:picChg chg="add mod">
          <ac:chgData name="Stian Knappskog" userId="fd9e34d2-1fd7-4b4b-9e0f-0cfc302beb73" providerId="ADAL" clId="{F24C2087-A6AD-41A2-8CF4-4A5DE4A7A253}" dt="2021-07-20T14:59:34.697" v="10" actId="1076"/>
          <ac:picMkLst>
            <pc:docMk/>
            <pc:sldMk cId="3607890359" sldId="258"/>
            <ac:picMk id="3" creationId="{7FE61AD4-9FF5-4E16-AD61-AC7ED4DBDB67}"/>
          </ac:picMkLst>
        </pc:picChg>
        <pc:picChg chg="del">
          <ac:chgData name="Stian Knappskog" userId="fd9e34d2-1fd7-4b4b-9e0f-0cfc302beb73" providerId="ADAL" clId="{F24C2087-A6AD-41A2-8CF4-4A5DE4A7A253}" dt="2021-07-20T14:59:03.376" v="1" actId="478"/>
          <ac:picMkLst>
            <pc:docMk/>
            <pc:sldMk cId="3607890359" sldId="258"/>
            <ac:picMk id="6" creationId="{EEE70A50-4B63-4456-9F75-39E2B8DEBD1B}"/>
          </ac:picMkLst>
        </pc:picChg>
      </pc:sldChg>
      <pc:sldChg chg="addSp delSp modSp add mod">
        <pc:chgData name="Stian Knappskog" userId="fd9e34d2-1fd7-4b4b-9e0f-0cfc302beb73" providerId="ADAL" clId="{F24C2087-A6AD-41A2-8CF4-4A5DE4A7A253}" dt="2021-07-21T11:46:06.917" v="23" actId="13926"/>
        <pc:sldMkLst>
          <pc:docMk/>
          <pc:sldMk cId="1549782722" sldId="259"/>
        </pc:sldMkLst>
        <pc:spChg chg="mod">
          <ac:chgData name="Stian Knappskog" userId="fd9e34d2-1fd7-4b4b-9e0f-0cfc302beb73" providerId="ADAL" clId="{F24C2087-A6AD-41A2-8CF4-4A5DE4A7A253}" dt="2021-07-20T15:13:39.782" v="20" actId="6549"/>
          <ac:spMkLst>
            <pc:docMk/>
            <pc:sldMk cId="1549782722" sldId="259"/>
            <ac:spMk id="8" creationId="{CF2FFABC-C889-43CA-9B7A-02ECEF9C6226}"/>
          </ac:spMkLst>
        </pc:spChg>
        <pc:spChg chg="mod">
          <ac:chgData name="Stian Knappskog" userId="fd9e34d2-1fd7-4b4b-9e0f-0cfc302beb73" providerId="ADAL" clId="{F24C2087-A6AD-41A2-8CF4-4A5DE4A7A253}" dt="2021-07-21T11:46:06.917" v="23" actId="13926"/>
          <ac:spMkLst>
            <pc:docMk/>
            <pc:sldMk cId="1549782722" sldId="259"/>
            <ac:spMk id="11" creationId="{C1DB2622-F3AE-4033-B7CF-A159E4CC6AE6}"/>
          </ac:spMkLst>
        </pc:spChg>
        <pc:picChg chg="del">
          <ac:chgData name="Stian Knappskog" userId="fd9e34d2-1fd7-4b4b-9e0f-0cfc302beb73" providerId="ADAL" clId="{F24C2087-A6AD-41A2-8CF4-4A5DE4A7A253}" dt="2021-07-20T15:13:21.591" v="12" actId="478"/>
          <ac:picMkLst>
            <pc:docMk/>
            <pc:sldMk cId="1549782722" sldId="259"/>
            <ac:picMk id="3" creationId="{7FE61AD4-9FF5-4E16-AD61-AC7ED4DBDB67}"/>
          </ac:picMkLst>
        </pc:picChg>
        <pc:picChg chg="add mod">
          <ac:chgData name="Stian Knappskog" userId="fd9e34d2-1fd7-4b4b-9e0f-0cfc302beb73" providerId="ADAL" clId="{F24C2087-A6AD-41A2-8CF4-4A5DE4A7A253}" dt="2021-07-20T15:13:37.442" v="18" actId="14100"/>
          <ac:picMkLst>
            <pc:docMk/>
            <pc:sldMk cId="1549782722" sldId="259"/>
            <ac:picMk id="4" creationId="{6C84D584-4900-4624-B0A7-BDBF37C3D756}"/>
          </ac:picMkLst>
        </pc:picChg>
      </pc:sldChg>
    </pc:docChg>
  </pc:docChgLst>
  <pc:docChgLst>
    <pc:chgData name="Nigar Sofiyeva" userId="d39a9056-b92e-4cc7-a525-2313fa5cd2cb" providerId="ADAL" clId="{ACA67187-DC9F-402A-ABAD-0AA553EC3364}"/>
    <pc:docChg chg="undo custSel addSld modSld">
      <pc:chgData name="Nigar Sofiyeva" userId="d39a9056-b92e-4cc7-a525-2313fa5cd2cb" providerId="ADAL" clId="{ACA67187-DC9F-402A-ABAD-0AA553EC3364}" dt="2022-03-04T13:34:18.259" v="45" actId="20577"/>
      <pc:docMkLst>
        <pc:docMk/>
      </pc:docMkLst>
      <pc:sldChg chg="addSp delSp modSp mod">
        <pc:chgData name="Nigar Sofiyeva" userId="d39a9056-b92e-4cc7-a525-2313fa5cd2cb" providerId="ADAL" clId="{ACA67187-DC9F-402A-ABAD-0AA553EC3364}" dt="2021-07-29T21:07:34.330" v="8" actId="14100"/>
        <pc:sldMkLst>
          <pc:docMk/>
          <pc:sldMk cId="3455137915" sldId="257"/>
        </pc:sldMkLst>
        <pc:picChg chg="add mod">
          <ac:chgData name="Nigar Sofiyeva" userId="d39a9056-b92e-4cc7-a525-2313fa5cd2cb" providerId="ADAL" clId="{ACA67187-DC9F-402A-ABAD-0AA553EC3364}" dt="2021-07-29T21:07:34.330" v="8" actId="14100"/>
          <ac:picMkLst>
            <pc:docMk/>
            <pc:sldMk cId="3455137915" sldId="257"/>
            <ac:picMk id="3" creationId="{C337BDD6-0177-4F35-85B5-3DD7BD3760B4}"/>
          </ac:picMkLst>
        </pc:picChg>
        <pc:picChg chg="del">
          <ac:chgData name="Nigar Sofiyeva" userId="d39a9056-b92e-4cc7-a525-2313fa5cd2cb" providerId="ADAL" clId="{ACA67187-DC9F-402A-ABAD-0AA553EC3364}" dt="2021-07-29T21:06:55.346" v="0" actId="478"/>
          <ac:picMkLst>
            <pc:docMk/>
            <pc:sldMk cId="3455137915" sldId="257"/>
            <ac:picMk id="4" creationId="{CB79A772-F00E-413F-B1AB-A86C15FB054C}"/>
          </ac:picMkLst>
        </pc:picChg>
      </pc:sldChg>
      <pc:sldChg chg="addSp delSp modSp mod">
        <pc:chgData name="Nigar Sofiyeva" userId="d39a9056-b92e-4cc7-a525-2313fa5cd2cb" providerId="ADAL" clId="{ACA67187-DC9F-402A-ABAD-0AA553EC3364}" dt="2021-07-29T21:11:18.001" v="18" actId="1076"/>
        <pc:sldMkLst>
          <pc:docMk/>
          <pc:sldMk cId="3607890359" sldId="258"/>
        </pc:sldMkLst>
        <pc:picChg chg="add mod">
          <ac:chgData name="Nigar Sofiyeva" userId="d39a9056-b92e-4cc7-a525-2313fa5cd2cb" providerId="ADAL" clId="{ACA67187-DC9F-402A-ABAD-0AA553EC3364}" dt="2021-07-29T21:11:18.001" v="18" actId="1076"/>
          <ac:picMkLst>
            <pc:docMk/>
            <pc:sldMk cId="3607890359" sldId="258"/>
            <ac:picMk id="3" creationId="{9BEE5500-4267-44C1-B342-0F7DD86B31D3}"/>
          </ac:picMkLst>
        </pc:picChg>
        <pc:picChg chg="del">
          <ac:chgData name="Nigar Sofiyeva" userId="d39a9056-b92e-4cc7-a525-2313fa5cd2cb" providerId="ADAL" clId="{ACA67187-DC9F-402A-ABAD-0AA553EC3364}" dt="2021-07-29T21:10:54.866" v="9" actId="478"/>
          <ac:picMkLst>
            <pc:docMk/>
            <pc:sldMk cId="3607890359" sldId="258"/>
            <ac:picMk id="4" creationId="{C40871DB-248E-4E52-8728-41BA4A885841}"/>
          </ac:picMkLst>
        </pc:picChg>
      </pc:sldChg>
      <pc:sldChg chg="addSp delSp modSp mod">
        <pc:chgData name="Nigar Sofiyeva" userId="d39a9056-b92e-4cc7-a525-2313fa5cd2cb" providerId="ADAL" clId="{ACA67187-DC9F-402A-ABAD-0AA553EC3364}" dt="2021-07-29T21:14:23.513" v="25" actId="1076"/>
        <pc:sldMkLst>
          <pc:docMk/>
          <pc:sldMk cId="1549782722" sldId="259"/>
        </pc:sldMkLst>
        <pc:picChg chg="add mod">
          <ac:chgData name="Nigar Sofiyeva" userId="d39a9056-b92e-4cc7-a525-2313fa5cd2cb" providerId="ADAL" clId="{ACA67187-DC9F-402A-ABAD-0AA553EC3364}" dt="2021-07-29T21:14:23.513" v="25" actId="1076"/>
          <ac:picMkLst>
            <pc:docMk/>
            <pc:sldMk cId="1549782722" sldId="259"/>
            <ac:picMk id="3" creationId="{30FF8781-C20D-48FB-81F9-5B1DA6F358C7}"/>
          </ac:picMkLst>
        </pc:picChg>
        <pc:picChg chg="del">
          <ac:chgData name="Nigar Sofiyeva" userId="d39a9056-b92e-4cc7-a525-2313fa5cd2cb" providerId="ADAL" clId="{ACA67187-DC9F-402A-ABAD-0AA553EC3364}" dt="2021-07-29T21:13:22.587" v="19" actId="478"/>
          <ac:picMkLst>
            <pc:docMk/>
            <pc:sldMk cId="1549782722" sldId="259"/>
            <ac:picMk id="4" creationId="{65E31E23-1276-40C1-97E7-CC1421B2C17C}"/>
          </ac:picMkLst>
        </pc:picChg>
      </pc:sldChg>
      <pc:sldChg chg="addSp delSp modSp new mod">
        <pc:chgData name="Nigar Sofiyeva" userId="d39a9056-b92e-4cc7-a525-2313fa5cd2cb" providerId="ADAL" clId="{ACA67187-DC9F-402A-ABAD-0AA553EC3364}" dt="2022-03-04T13:34:18.259" v="45" actId="20577"/>
        <pc:sldMkLst>
          <pc:docMk/>
          <pc:sldMk cId="867370080" sldId="260"/>
        </pc:sldMkLst>
        <pc:spChg chg="del">
          <ac:chgData name="Nigar Sofiyeva" userId="d39a9056-b92e-4cc7-a525-2313fa5cd2cb" providerId="ADAL" clId="{ACA67187-DC9F-402A-ABAD-0AA553EC3364}" dt="2022-03-04T13:32:21.819" v="28" actId="478"/>
          <ac:spMkLst>
            <pc:docMk/>
            <pc:sldMk cId="867370080" sldId="260"/>
            <ac:spMk id="2" creationId="{DB884B46-A38E-42F5-B859-ADF71C995FF5}"/>
          </ac:spMkLst>
        </pc:spChg>
        <pc:spChg chg="del">
          <ac:chgData name="Nigar Sofiyeva" userId="d39a9056-b92e-4cc7-a525-2313fa5cd2cb" providerId="ADAL" clId="{ACA67187-DC9F-402A-ABAD-0AA553EC3364}" dt="2022-03-04T13:32:23.754" v="29" actId="478"/>
          <ac:spMkLst>
            <pc:docMk/>
            <pc:sldMk cId="867370080" sldId="260"/>
            <ac:spMk id="3" creationId="{C1451D49-A3E7-4C1C-A8CE-137809802C9F}"/>
          </ac:spMkLst>
        </pc:spChg>
        <pc:spChg chg="add mod">
          <ac:chgData name="Nigar Sofiyeva" userId="d39a9056-b92e-4cc7-a525-2313fa5cd2cb" providerId="ADAL" clId="{ACA67187-DC9F-402A-ABAD-0AA553EC3364}" dt="2022-03-04T13:34:18.259" v="45" actId="20577"/>
          <ac:spMkLst>
            <pc:docMk/>
            <pc:sldMk cId="867370080" sldId="260"/>
            <ac:spMk id="4" creationId="{C377720F-58A7-469B-AFCF-65646E9D6A9B}"/>
          </ac:spMkLst>
        </pc:spChg>
        <pc:picChg chg="add mod">
          <ac:chgData name="Nigar Sofiyeva" userId="d39a9056-b92e-4cc7-a525-2313fa5cd2cb" providerId="ADAL" clId="{ACA67187-DC9F-402A-ABAD-0AA553EC3364}" dt="2022-03-04T13:34:12.080" v="42" actId="1076"/>
          <ac:picMkLst>
            <pc:docMk/>
            <pc:sldMk cId="867370080" sldId="260"/>
            <ac:picMk id="5" creationId="{AE1C8DE7-F1A0-4D35-AD96-37AFE9377B87}"/>
          </ac:picMkLst>
        </pc:picChg>
        <pc:picChg chg="add mod">
          <ac:chgData name="Nigar Sofiyeva" userId="d39a9056-b92e-4cc7-a525-2313fa5cd2cb" providerId="ADAL" clId="{ACA67187-DC9F-402A-ABAD-0AA553EC3364}" dt="2022-03-04T13:34:13.521" v="43" actId="1076"/>
          <ac:picMkLst>
            <pc:docMk/>
            <pc:sldMk cId="867370080" sldId="260"/>
            <ac:picMk id="6" creationId="{70034EE6-D1F7-4129-9F1B-D7E1332B52A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10617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15549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76171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08973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55604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04483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63568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97576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02988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04805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05498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A7CA91-1B5A-410E-BD42-A1684D6D646E}" type="datetimeFigureOut">
              <a:rPr lang="nb-NO" smtClean="0"/>
              <a:t>30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502B6-09E5-4547-A49E-1A9AF698271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24829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F2FFABC-C889-43CA-9B7A-02ECEF9C6226}"/>
              </a:ext>
            </a:extLst>
          </p:cNvPr>
          <p:cNvSpPr txBox="1"/>
          <p:nvPr/>
        </p:nvSpPr>
        <p:spPr>
          <a:xfrm>
            <a:off x="106680" y="1600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1</a:t>
            </a:r>
          </a:p>
        </p:txBody>
      </p:sp>
      <p:pic>
        <p:nvPicPr>
          <p:cNvPr id="4" name="Picture 3" descr="Chart, bar chart&#10;&#10;Description automatically generated">
            <a:extLst>
              <a:ext uri="{FF2B5EF4-FFF2-40B4-BE49-F238E27FC236}">
                <a16:creationId xmlns:a16="http://schemas.microsoft.com/office/drawing/2014/main" id="{BCF6BC19-84B3-47A9-9F9F-3DF2D7F93F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6" y="1554600"/>
            <a:ext cx="4352379" cy="3166257"/>
          </a:xfrm>
          <a:prstGeom prst="rect">
            <a:avLst/>
          </a:prstGeom>
        </p:spPr>
      </p:pic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01E3492D-7C82-437C-877C-C674B9975B6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2764" y="1554601"/>
            <a:ext cx="4352380" cy="3166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7222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F2FFABC-C889-43CA-9B7A-02ECEF9C6226}"/>
              </a:ext>
            </a:extLst>
          </p:cNvPr>
          <p:cNvSpPr txBox="1"/>
          <p:nvPr/>
        </p:nvSpPr>
        <p:spPr>
          <a:xfrm>
            <a:off x="106680" y="1600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2</a:t>
            </a:r>
          </a:p>
        </p:txBody>
      </p:sp>
      <p:pic>
        <p:nvPicPr>
          <p:cNvPr id="4" name="Picture 3" descr="Chart, box and whisker chart&#10;&#10;Description automatically generated">
            <a:extLst>
              <a:ext uri="{FF2B5EF4-FFF2-40B4-BE49-F238E27FC236}">
                <a16:creationId xmlns:a16="http://schemas.microsoft.com/office/drawing/2014/main" id="{952DA984-B4AC-438E-B823-998EABDF0A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381" y="702733"/>
            <a:ext cx="7345238" cy="56422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51379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F2FFABC-C889-43CA-9B7A-02ECEF9C6226}"/>
              </a:ext>
            </a:extLst>
          </p:cNvPr>
          <p:cNvSpPr txBox="1"/>
          <p:nvPr/>
        </p:nvSpPr>
        <p:spPr>
          <a:xfrm>
            <a:off x="106680" y="1600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3</a:t>
            </a:r>
          </a:p>
        </p:txBody>
      </p:sp>
      <p:pic>
        <p:nvPicPr>
          <p:cNvPr id="4" name="Picture 3" descr="Chart, box and whisker chart&#10;&#10;Description automatically generated">
            <a:extLst>
              <a:ext uri="{FF2B5EF4-FFF2-40B4-BE49-F238E27FC236}">
                <a16:creationId xmlns:a16="http://schemas.microsoft.com/office/drawing/2014/main" id="{C87E0E74-926D-4C84-A7A4-A984AE2907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750" y="795865"/>
            <a:ext cx="7178384" cy="5466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78903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F2FFABC-C889-43CA-9B7A-02ECEF9C6226}"/>
              </a:ext>
            </a:extLst>
          </p:cNvPr>
          <p:cNvSpPr txBox="1"/>
          <p:nvPr/>
        </p:nvSpPr>
        <p:spPr>
          <a:xfrm>
            <a:off x="106680" y="1600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 dirty="0"/>
              <a:t> 4</a:t>
            </a:r>
          </a:p>
        </p:txBody>
      </p:sp>
      <p:pic>
        <p:nvPicPr>
          <p:cNvPr id="4" name="Picture 3" descr="Chart, box and whisker chart&#10;&#10;Description automatically generated">
            <a:extLst>
              <a:ext uri="{FF2B5EF4-FFF2-40B4-BE49-F238E27FC236}">
                <a16:creationId xmlns:a16="http://schemas.microsoft.com/office/drawing/2014/main" id="{5CCFC48C-22E5-4B34-969E-F15CD94F38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733" y="1171377"/>
            <a:ext cx="8636000" cy="4515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97827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377720F-58A7-469B-AFCF-65646E9D6A9B}"/>
              </a:ext>
            </a:extLst>
          </p:cNvPr>
          <p:cNvSpPr txBox="1"/>
          <p:nvPr/>
        </p:nvSpPr>
        <p:spPr>
          <a:xfrm>
            <a:off x="106680" y="16002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upplementary</a:t>
            </a:r>
            <a:r>
              <a:rPr lang="nb-NO" dirty="0"/>
              <a:t> </a:t>
            </a:r>
            <a:r>
              <a:rPr lang="nb-NO" dirty="0" err="1"/>
              <a:t>Figure</a:t>
            </a:r>
            <a:r>
              <a:rPr lang="nb-NO"/>
              <a:t> 5</a:t>
            </a:r>
            <a:endParaRPr lang="nb-NO" dirty="0"/>
          </a:p>
        </p:txBody>
      </p:sp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C8DC47F1-4E0F-40F0-B55A-9A6E76D942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301" y="808341"/>
            <a:ext cx="7464906" cy="52413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7370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2</TotalTime>
  <Words>15</Words>
  <Application>Microsoft Office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an Knappskog</dc:creator>
  <cp:lastModifiedBy>Nigar Sofiyeva</cp:lastModifiedBy>
  <cp:revision>4</cp:revision>
  <dcterms:created xsi:type="dcterms:W3CDTF">2021-07-20T09:16:48Z</dcterms:created>
  <dcterms:modified xsi:type="dcterms:W3CDTF">2022-08-30T17:12:41Z</dcterms:modified>
</cp:coreProperties>
</file>